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720" r:id="rId1"/>
  </p:sldMasterIdLst>
  <p:notesMasterIdLst>
    <p:notesMasterId r:id="rId3"/>
  </p:notesMasterIdLst>
  <p:sldIdLst>
    <p:sldId id="297" r:id="rId2"/>
  </p:sldIdLst>
  <p:sldSz cx="7559675" cy="10691813"/>
  <p:notesSz cx="6858000" cy="9144000"/>
  <p:defaultTextStyle>
    <a:defPPr>
      <a:defRPr lang="zh-CN"/>
    </a:defPPr>
    <a:lvl1pPr marL="0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1pPr>
    <a:lvl2pPr marL="477809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2pPr>
    <a:lvl3pPr marL="955618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3pPr>
    <a:lvl4pPr marL="1433427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4pPr>
    <a:lvl5pPr marL="1911237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5pPr>
    <a:lvl6pPr marL="2389046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6pPr>
    <a:lvl7pPr marL="2866855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7pPr>
    <a:lvl8pPr marL="3344664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8pPr>
    <a:lvl9pPr marL="3822473" algn="l" defTabSz="955618" rtl="0" eaLnBrk="1" latinLnBrk="0" hangingPunct="1">
      <a:defRPr sz="188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4D4D4"/>
    <a:srgbClr val="606060"/>
    <a:srgbClr val="C7BD15"/>
    <a:srgbClr val="5E3F3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927" autoAdjust="0"/>
    <p:restoredTop sz="94660"/>
  </p:normalViewPr>
  <p:slideViewPr>
    <p:cSldViewPr snapToGrid="0">
      <p:cViewPr>
        <p:scale>
          <a:sx n="100" d="100"/>
          <a:sy n="100" d="100"/>
        </p:scale>
        <p:origin x="606" y="-17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D9A1D1-FA4B-4BFE-8CB1-BCF9D3D3172D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A86657-A7F8-4317-B62B-26FBC9188D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66220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1pPr>
    <a:lvl2pPr marL="702351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2pPr>
    <a:lvl3pPr marL="1404701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3pPr>
    <a:lvl4pPr marL="2107052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4pPr>
    <a:lvl5pPr marL="2809403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5pPr>
    <a:lvl6pPr marL="3511753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6pPr>
    <a:lvl7pPr marL="4214104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7pPr>
    <a:lvl8pPr marL="4916454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8pPr>
    <a:lvl9pPr marL="5618805" algn="l" defTabSz="1404701" rtl="0" eaLnBrk="1" latinLnBrk="0" hangingPunct="1">
      <a:defRPr sz="184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4089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9713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3483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5424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8803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2450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41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2613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5928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6177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9813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877E45-2E4F-449D-AA81-A38A89EDEEEC}" type="datetimeFigureOut">
              <a:rPr lang="zh-CN" altLang="en-US" smtClean="0"/>
              <a:t>2021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99B6B6-0DE3-4F25-A449-77854D199D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6046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539751" y="1050449"/>
            <a:ext cx="6480175" cy="1833172"/>
            <a:chOff x="539751" y="2650649"/>
            <a:chExt cx="6480175" cy="1833172"/>
          </a:xfrm>
        </p:grpSpPr>
        <p:sp>
          <p:nvSpPr>
            <p:cNvPr id="19" name="矩形 18"/>
            <p:cNvSpPr/>
            <p:nvPr/>
          </p:nvSpPr>
          <p:spPr>
            <a:xfrm>
              <a:off x="539751" y="2650649"/>
              <a:ext cx="6480175" cy="183317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/>
            </a:p>
          </p:txBody>
        </p:sp>
        <p:pic>
          <p:nvPicPr>
            <p:cNvPr id="20" name="Size vs TBR.tiff" descr="Size vs TBR.tiff"/>
            <p:cNvPicPr>
              <a:picLocks noChangeAspect="1"/>
            </p:cNvPicPr>
            <p:nvPr/>
          </p:nvPicPr>
          <p:blipFill>
            <a:blip r:embed="rId2">
              <a:extLst/>
            </a:blip>
            <a:stretch>
              <a:fillRect/>
            </a:stretch>
          </p:blipFill>
          <p:spPr>
            <a:xfrm>
              <a:off x="870625" y="2683821"/>
              <a:ext cx="2011224" cy="1800000"/>
            </a:xfrm>
            <a:prstGeom prst="rect">
              <a:avLst/>
            </a:prstGeom>
            <a:ln w="12700">
              <a:miter lim="400000"/>
            </a:ln>
          </p:spPr>
        </p:pic>
        <p:pic>
          <p:nvPicPr>
            <p:cNvPr id="21" name="Size vs PETCT.tiff" descr="Size vs PETCT.tiff"/>
            <p:cNvPicPr>
              <a:picLocks noChangeAspect="1"/>
            </p:cNvPicPr>
            <p:nvPr/>
          </p:nvPicPr>
          <p:blipFill>
            <a:blip r:embed="rId3">
              <a:extLst/>
            </a:blip>
            <a:stretch>
              <a:fillRect/>
            </a:stretch>
          </p:blipFill>
          <p:spPr>
            <a:xfrm>
              <a:off x="2766549" y="2678427"/>
              <a:ext cx="2020408" cy="1800000"/>
            </a:xfrm>
            <a:prstGeom prst="rect">
              <a:avLst/>
            </a:prstGeom>
            <a:ln w="12700">
              <a:miter lim="400000"/>
            </a:ln>
          </p:spPr>
        </p:pic>
        <p:pic>
          <p:nvPicPr>
            <p:cNvPr id="22" name="Size vs MSS.tiff" descr="Size vs MSS.tiff"/>
            <p:cNvPicPr>
              <a:picLocks noChangeAspect="1"/>
            </p:cNvPicPr>
            <p:nvPr/>
          </p:nvPicPr>
          <p:blipFill>
            <a:blip r:embed="rId4">
              <a:extLst/>
            </a:blip>
            <a:stretch>
              <a:fillRect/>
            </a:stretch>
          </p:blipFill>
          <p:spPr>
            <a:xfrm>
              <a:off x="4733583" y="2683821"/>
              <a:ext cx="2020408" cy="1800000"/>
            </a:xfrm>
            <a:prstGeom prst="rect">
              <a:avLst/>
            </a:prstGeom>
            <a:ln w="12700">
              <a:miter lim="400000"/>
            </a:ln>
          </p:spPr>
        </p:pic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xmlns="" id="{98A4670F-A2AF-4413-8691-DF2F7AE38E8B}"/>
                </a:ext>
              </a:extLst>
            </p:cNvPr>
            <p:cNvSpPr txBox="1"/>
            <p:nvPr/>
          </p:nvSpPr>
          <p:spPr>
            <a:xfrm>
              <a:off x="754910" y="2657325"/>
              <a:ext cx="2916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xmlns="" id="{2264EA60-B72B-42CB-AC68-E016DADC16C0}"/>
                </a:ext>
              </a:extLst>
            </p:cNvPr>
            <p:cNvSpPr txBox="1"/>
            <p:nvPr/>
          </p:nvSpPr>
          <p:spPr>
            <a:xfrm>
              <a:off x="2612221" y="2656249"/>
              <a:ext cx="2740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b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xmlns="" id="{B82115C4-F048-4681-8604-4267F2F526A5}"/>
                </a:ext>
              </a:extLst>
            </p:cNvPr>
            <p:cNvSpPr txBox="1"/>
            <p:nvPr/>
          </p:nvSpPr>
          <p:spPr>
            <a:xfrm>
              <a:off x="4579998" y="2656936"/>
              <a:ext cx="3062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c</a:t>
              </a:r>
              <a:endParaRPr lang="zh-CN" altLang="en-US" sz="1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9" name="文本框 8"/>
          <p:cNvSpPr txBox="1"/>
          <p:nvPr/>
        </p:nvSpPr>
        <p:spPr>
          <a:xfrm>
            <a:off x="482646" y="708660"/>
            <a:ext cx="6611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82646" y="3011899"/>
            <a:ext cx="661157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. Distribution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of TBR values, PET/CT or MSS indicated LME ranges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garding lesion size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sults showed no significant correlations was found, indicating that lesion size was not a TBR- or LME range-influencing factor in this study.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39077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95</TotalTime>
  <Words>46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黑体</vt:lpstr>
      <vt:lpstr>Arial</vt:lpstr>
      <vt:lpstr>Calibri</vt:lpstr>
      <vt:lpstr>Calibri Light</vt:lpstr>
      <vt:lpstr>等线</vt:lpstr>
      <vt:lpstr>等线 Light</vt:lpstr>
      <vt:lpstr>Office 主题​​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lojera, Michelle</cp:lastModifiedBy>
  <cp:revision>119</cp:revision>
  <dcterms:created xsi:type="dcterms:W3CDTF">2021-03-22T09:16:26Z</dcterms:created>
  <dcterms:modified xsi:type="dcterms:W3CDTF">2021-07-19T16:23:05Z</dcterms:modified>
</cp:coreProperties>
</file>